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28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pt-B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54885-82E3-4A0E-AC1F-34DE99580749}" type="datetimeFigureOut">
              <a:rPr lang="pt-BR" smtClean="0"/>
              <a:t>14/11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84C0D-7A6E-4835-8ED4-1DBDDB9DC4D1}" type="slidenum">
              <a:rPr lang="pt-BR" smtClean="0"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54885-82E3-4A0E-AC1F-34DE99580749}" type="datetimeFigureOut">
              <a:rPr lang="pt-BR" smtClean="0"/>
              <a:t>14/11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84C0D-7A6E-4835-8ED4-1DBDDB9DC4D1}" type="slidenum">
              <a:rPr lang="pt-BR" smtClean="0"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54885-82E3-4A0E-AC1F-34DE99580749}" type="datetimeFigureOut">
              <a:rPr lang="pt-BR" smtClean="0"/>
              <a:t>14/11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84C0D-7A6E-4835-8ED4-1DBDDB9DC4D1}" type="slidenum">
              <a:rPr lang="pt-BR" smtClean="0"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54885-82E3-4A0E-AC1F-34DE99580749}" type="datetimeFigureOut">
              <a:rPr lang="pt-BR" smtClean="0"/>
              <a:t>14/11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84C0D-7A6E-4835-8ED4-1DBDDB9DC4D1}" type="slidenum">
              <a:rPr lang="pt-BR" smtClean="0"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54885-82E3-4A0E-AC1F-34DE99580749}" type="datetimeFigureOut">
              <a:rPr lang="pt-BR" smtClean="0"/>
              <a:t>14/11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84C0D-7A6E-4835-8ED4-1DBDDB9DC4D1}" type="slidenum">
              <a:rPr lang="pt-BR" smtClean="0"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54885-82E3-4A0E-AC1F-34DE99580749}" type="datetimeFigureOut">
              <a:rPr lang="pt-BR" smtClean="0"/>
              <a:t>14/11/20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84C0D-7A6E-4835-8ED4-1DBDDB9DC4D1}" type="slidenum">
              <a:rPr lang="pt-BR" smtClean="0"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54885-82E3-4A0E-AC1F-34DE99580749}" type="datetimeFigureOut">
              <a:rPr lang="pt-BR" smtClean="0"/>
              <a:t>14/11/2018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84C0D-7A6E-4835-8ED4-1DBDDB9DC4D1}" type="slidenum">
              <a:rPr lang="pt-BR" smtClean="0"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54885-82E3-4A0E-AC1F-34DE99580749}" type="datetimeFigureOut">
              <a:rPr lang="pt-BR" smtClean="0"/>
              <a:t>14/11/2018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84C0D-7A6E-4835-8ED4-1DBDDB9DC4D1}" type="slidenum">
              <a:rPr lang="pt-BR" smtClean="0"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54885-82E3-4A0E-AC1F-34DE99580749}" type="datetimeFigureOut">
              <a:rPr lang="pt-BR" smtClean="0"/>
              <a:t>14/11/2018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84C0D-7A6E-4835-8ED4-1DBDDB9DC4D1}" type="slidenum">
              <a:rPr lang="pt-BR" smtClean="0"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54885-82E3-4A0E-AC1F-34DE99580749}" type="datetimeFigureOut">
              <a:rPr lang="pt-BR" smtClean="0"/>
              <a:t>14/11/20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84C0D-7A6E-4835-8ED4-1DBDDB9DC4D1}" type="slidenum">
              <a:rPr lang="pt-BR" smtClean="0"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54885-82E3-4A0E-AC1F-34DE99580749}" type="datetimeFigureOut">
              <a:rPr lang="pt-BR" smtClean="0"/>
              <a:t>14/11/20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84C0D-7A6E-4835-8ED4-1DBDDB9DC4D1}" type="slidenum">
              <a:rPr lang="pt-BR" smtClean="0"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C54885-82E3-4A0E-AC1F-34DE99580749}" type="datetimeFigureOut">
              <a:rPr lang="pt-BR" smtClean="0"/>
              <a:t>14/11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084C0D-7A6E-4835-8ED4-1DBDDB9DC4D1}" type="slidenum">
              <a:rPr lang="pt-BR" smtClean="0"/>
              <a:t>‹#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Micro\Downloads\S1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389376" y="2002536"/>
            <a:ext cx="2365248" cy="2852928"/>
          </a:xfrm>
          <a:prstGeom prst="rect">
            <a:avLst/>
          </a:prstGeom>
          <a:noFill/>
        </p:spPr>
      </p:pic>
      <p:sp>
        <p:nvSpPr>
          <p:cNvPr id="5" name="Rectangle 4"/>
          <p:cNvSpPr/>
          <p:nvPr/>
        </p:nvSpPr>
        <p:spPr>
          <a:xfrm>
            <a:off x="0" y="142852"/>
            <a:ext cx="9144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err="1"/>
              <a:t>Hexosamine</a:t>
            </a:r>
            <a:r>
              <a:rPr lang="en-US" b="1" dirty="0"/>
              <a:t> Biosynthetic Pathway and glycosylation regulate cell migration in Melanoma Cells</a:t>
            </a:r>
            <a:endParaRPr lang="pt-BR" dirty="0"/>
          </a:p>
        </p:txBody>
      </p:sp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71438" y="500042"/>
            <a:ext cx="8715404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Rafaela Muniz de Queiroz</a:t>
            </a:r>
            <a:r>
              <a:rPr kumimoji="0" lang="pt-BR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1</a:t>
            </a: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, Isadora Araújo Oliveira</a:t>
            </a:r>
            <a:r>
              <a:rPr kumimoji="0" lang="pt-BR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1</a:t>
            </a: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, Bruno Piva</a:t>
            </a:r>
            <a:r>
              <a:rPr kumimoji="0" lang="pt-BR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3</a:t>
            </a: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, Felipe Bouchuid Catão</a:t>
            </a:r>
            <a:r>
              <a:rPr kumimoji="0" lang="pt-BR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2,3</a:t>
            </a: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,Bruno da Costa Rodrigues</a:t>
            </a:r>
            <a:r>
              <a:rPr kumimoji="0" lang="pt-BR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1</a:t>
            </a: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, </a:t>
            </a: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mbria" pitchFamily="18" charset="0"/>
                <a:cs typeface="Times New Roman" pitchFamily="18" charset="0"/>
              </a:rPr>
              <a:t>Adriana da Costa Pascoal</a:t>
            </a:r>
            <a:r>
              <a:rPr kumimoji="0" lang="pt-BR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1</a:t>
            </a: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mbria" pitchFamily="18" charset="0"/>
                <a:cs typeface="Times New Roman" pitchFamily="18" charset="0"/>
              </a:rPr>
              <a:t>,</a:t>
            </a: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Bruno Lourenço Diaz</a:t>
            </a:r>
            <a:r>
              <a:rPr kumimoji="0" lang="pt-BR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3</a:t>
            </a: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,Adriane Regina Todeschini</a:t>
            </a:r>
            <a:r>
              <a:rPr kumimoji="0" lang="pt-BR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1</a:t>
            </a: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, Michelle Botelho Caarls</a:t>
            </a:r>
            <a:r>
              <a:rPr kumimoji="0" lang="pt-BR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2</a:t>
            </a: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, Wagner Barbosa Dias</a:t>
            </a:r>
            <a:r>
              <a:rPr kumimoji="0" lang="pt-BR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1*</a:t>
            </a:r>
            <a:r>
              <a:rPr kumimoji="0" lang="pt-B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</a:t>
            </a:r>
            <a:r>
              <a:rPr kumimoji="0" lang="pt-BR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7158" y="1214422"/>
            <a:ext cx="8219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u="sng" dirty="0" smtClean="0"/>
              <a:t>Supplentary Figure 1:</a:t>
            </a:r>
            <a:r>
              <a:rPr lang="pt-BR" b="1" dirty="0" smtClean="0"/>
              <a:t>  </a:t>
            </a:r>
            <a:r>
              <a:rPr lang="en-US" dirty="0" smtClean="0"/>
              <a:t>Impact of glucosamine and TMG treatments in </a:t>
            </a:r>
            <a:r>
              <a:rPr lang="en-US" i="1" dirty="0" smtClean="0"/>
              <a:t>O</a:t>
            </a:r>
            <a:r>
              <a:rPr lang="en-US" dirty="0" smtClean="0"/>
              <a:t>-</a:t>
            </a:r>
            <a:r>
              <a:rPr lang="en-US" dirty="0" err="1" smtClean="0"/>
              <a:t>GlcNAcylation</a:t>
            </a:r>
            <a:endParaRPr lang="pt-BR" dirty="0"/>
          </a:p>
        </p:txBody>
      </p:sp>
      <p:sp>
        <p:nvSpPr>
          <p:cNvPr id="8" name="TextBox 7"/>
          <p:cNvSpPr txBox="1"/>
          <p:nvPr/>
        </p:nvSpPr>
        <p:spPr>
          <a:xfrm>
            <a:off x="571472" y="5429264"/>
            <a:ext cx="83582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smtClean="0"/>
              <a:t>Human melanoma cells were incubated with</a:t>
            </a:r>
            <a:r>
              <a:rPr lang="en-US" dirty="0" smtClean="0"/>
              <a:t> </a:t>
            </a:r>
            <a:r>
              <a:rPr lang="en-US" dirty="0" err="1"/>
              <a:t>GlcN</a:t>
            </a:r>
            <a:r>
              <a:rPr lang="en-US" dirty="0"/>
              <a:t> (10 </a:t>
            </a:r>
            <a:r>
              <a:rPr lang="en-US" dirty="0" err="1"/>
              <a:t>mM</a:t>
            </a:r>
            <a:r>
              <a:rPr lang="en-US" dirty="0"/>
              <a:t>) </a:t>
            </a:r>
            <a:r>
              <a:rPr lang="en-US" dirty="0" smtClean="0"/>
              <a:t>or </a:t>
            </a:r>
            <a:r>
              <a:rPr lang="en-US" dirty="0"/>
              <a:t>TMG (10 µM) </a:t>
            </a:r>
            <a:r>
              <a:rPr lang="en-US" dirty="0" smtClean="0"/>
              <a:t> for 20h and </a:t>
            </a:r>
            <a:r>
              <a:rPr lang="pt-BR" dirty="0" smtClean="0"/>
              <a:t> cellular extracts were submitted to WB for O-GlcNAcylation. </a:t>
            </a:r>
            <a:endParaRPr lang="pt-BR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90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ro</dc:creator>
  <cp:lastModifiedBy>Micro</cp:lastModifiedBy>
  <cp:revision>1</cp:revision>
  <dcterms:created xsi:type="dcterms:W3CDTF">2018-11-14T17:20:24Z</dcterms:created>
  <dcterms:modified xsi:type="dcterms:W3CDTF">2018-11-14T17:28:57Z</dcterms:modified>
</cp:coreProperties>
</file>